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70" d="100"/>
          <a:sy n="70" d="100"/>
        </p:scale>
        <p:origin x="112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DB5930-5315-407E-8BC1-0CB504B0D1F0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CBEF42-7286-4A8F-979B-90D6F97017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893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E657BC-3D21-08AD-1603-FBD077F5E6F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1C924CD5-0B6E-5B26-52C1-34BA880D5FF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FB66F761-8B36-C84C-4CB9-A3CFE10355E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FC5A4A5-CBD8-3E4A-0C1C-26F623A4AFE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A695CD-C321-4EB9-BE90-4567FDA8C87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80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596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7867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052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3853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54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268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6688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361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121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4247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522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FA0141-E8E5-4279-BF69-6921EF9FB353}" type="datetimeFigureOut">
              <a:rPr kumimoji="1" lang="ja-JP" altLang="en-US" smtClean="0"/>
              <a:t>2024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F41EE7-08A4-4431-A28E-3AD06E2C1B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829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97B996-3EF3-7C52-9EC2-0BCCC8ADD1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F98BD1BE-E9CC-E656-A1C3-C3090B8EFFE7}"/>
              </a:ext>
            </a:extLst>
          </p:cNvPr>
          <p:cNvSpPr/>
          <p:nvPr/>
        </p:nvSpPr>
        <p:spPr>
          <a:xfrm>
            <a:off x="794557" y="1323722"/>
            <a:ext cx="4217322" cy="67189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Patients screened for suspected sepsis</a:t>
            </a:r>
            <a:r>
              <a:rPr lang="ja-JP" altLang="en-US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(n=58)</a:t>
            </a:r>
            <a:endParaRPr lang="ja-JP" altLang="en-US" dirty="0">
              <a:latin typeface="Times New Roman" panose="02020603050405020304" pitchFamily="18" charset="0"/>
              <a:ea typeface="游ゴシック Medium" panose="020B05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2046FADF-46AC-36CA-2A8C-30C43CBA64CE}"/>
              </a:ext>
            </a:extLst>
          </p:cNvPr>
          <p:cNvSpPr/>
          <p:nvPr/>
        </p:nvSpPr>
        <p:spPr>
          <a:xfrm>
            <a:off x="1828800" y="4467661"/>
            <a:ext cx="2148840" cy="54709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Analyzed Patients (n=52)</a:t>
            </a:r>
            <a:endParaRPr lang="ja-JP" altLang="en-US" dirty="0">
              <a:latin typeface="Times New Roman" panose="02020603050405020304" pitchFamily="18" charset="0"/>
              <a:ea typeface="游ゴシック Medium" panose="020B05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EB0CF61-F896-F405-65C0-BEA3F0367B37}"/>
              </a:ext>
            </a:extLst>
          </p:cNvPr>
          <p:cNvSpPr/>
          <p:nvPr/>
        </p:nvSpPr>
        <p:spPr>
          <a:xfrm>
            <a:off x="4150563" y="2617259"/>
            <a:ext cx="3832148" cy="122875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Excluded (n=6)</a:t>
            </a:r>
          </a:p>
          <a:p>
            <a:r>
              <a:rPr lang="ja-JP" altLang="en-US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 ・</a:t>
            </a:r>
            <a:r>
              <a:rPr lang="en-US" altLang="ja-JP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Declined to participate (n=2)</a:t>
            </a:r>
          </a:p>
          <a:p>
            <a:r>
              <a:rPr lang="ja-JP" altLang="en-US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 ・</a:t>
            </a:r>
            <a:r>
              <a:rPr lang="en-US" altLang="ja-JP" dirty="0">
                <a:latin typeface="Times New Roman" panose="02020603050405020304" pitchFamily="18" charset="0"/>
                <a:ea typeface="游ゴシック Medium" panose="020B0500000000000000" pitchFamily="50" charset="-128"/>
                <a:cs typeface="Times New Roman" panose="02020603050405020304" pitchFamily="18" charset="0"/>
              </a:rPr>
              <a:t>Not meeting Sepsis-3 criteria (n=4)</a:t>
            </a: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02F164B4-6D7A-94BE-2A7E-ACBBF43FB637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2903218" y="1995616"/>
            <a:ext cx="2" cy="2472045"/>
          </a:xfrm>
          <a:prstGeom prst="straightConnector1">
            <a:avLst/>
          </a:prstGeom>
          <a:ln cap="sq" cmpd="sng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AA1669FB-DB60-E2E8-EA9F-A651D5B69CDD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2903218" y="3231638"/>
            <a:ext cx="1247345" cy="0"/>
          </a:xfrm>
          <a:prstGeom prst="straightConnector1">
            <a:avLst/>
          </a:prstGeom>
          <a:ln cap="sq" cmpd="sng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5D11DE1-6DFE-75A5-6F72-287658D16E08}"/>
              </a:ext>
            </a:extLst>
          </p:cNvPr>
          <p:cNvSpPr txBox="1"/>
          <p:nvPr/>
        </p:nvSpPr>
        <p:spPr>
          <a:xfrm>
            <a:off x="205738" y="87700"/>
            <a:ext cx="2697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841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6</TotalTime>
  <Words>48</Words>
  <Application>Microsoft Office PowerPoint</Application>
  <PresentationFormat>画面に合わせる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幸 服部</dc:creator>
  <cp:lastModifiedBy>知也 菊谷</cp:lastModifiedBy>
  <cp:revision>4</cp:revision>
  <dcterms:created xsi:type="dcterms:W3CDTF">2024-10-11T06:03:59Z</dcterms:created>
  <dcterms:modified xsi:type="dcterms:W3CDTF">2024-10-13T05:34:36Z</dcterms:modified>
</cp:coreProperties>
</file>